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18" autoAdjust="0"/>
    <p:restoredTop sz="94660"/>
  </p:normalViewPr>
  <p:slideViewPr>
    <p:cSldViewPr snapToGrid="0">
      <p:cViewPr varScale="1">
        <p:scale>
          <a:sx n="92" d="100"/>
          <a:sy n="92" d="100"/>
        </p:scale>
        <p:origin x="7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322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608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8885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1264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8371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7899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672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104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547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868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6443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BC1798-6D73-4461-8060-600EB4F62952}" type="datetimeFigureOut">
              <a:rPr lang="en-US" smtClean="0"/>
              <a:t>4/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E4A42-2CFD-412D-903A-5EC1F81DCA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4053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4886" y="2190428"/>
            <a:ext cx="3939010" cy="43665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146628" y="3086410"/>
            <a:ext cx="748211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dditional file 3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Verification of graft transmission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of appl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luteoviru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1 to apple seedlings by RT-PCR using primers AluDetF6/R6 (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Table S1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. Lanes M) 1 kb plus DNA ladder;  1-3) from PA13; 4-6) from PA14; 7-9) from PA18; 10-12) from PA21; 13) PA14; 14) water. Arrow indicate the DNA fragment with labeled size.</a:t>
            </a:r>
          </a:p>
        </p:txBody>
      </p:sp>
      <p:cxnSp>
        <p:nvCxnSpPr>
          <p:cNvPr id="4" name="Straight Arrow Connector 3"/>
          <p:cNvCxnSpPr/>
          <p:nvPr/>
        </p:nvCxnSpPr>
        <p:spPr>
          <a:xfrm>
            <a:off x="2725560" y="2381149"/>
            <a:ext cx="76200" cy="0"/>
          </a:xfrm>
          <a:prstGeom prst="straightConnector1">
            <a:avLst/>
          </a:prstGeom>
          <a:ln w="28575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743427" y="1963050"/>
            <a:ext cx="40854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   1     2     3    4     5     6     7     8     9   10   11   12   13   14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148112" y="2235204"/>
            <a:ext cx="607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04718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</TotalTime>
  <Words>86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Ruhui</dc:creator>
  <cp:lastModifiedBy>Li, Ruhui</cp:lastModifiedBy>
  <cp:revision>8</cp:revision>
  <dcterms:created xsi:type="dcterms:W3CDTF">2017-12-17T15:09:08Z</dcterms:created>
  <dcterms:modified xsi:type="dcterms:W3CDTF">2018-04-05T21:11:39Z</dcterms:modified>
</cp:coreProperties>
</file>